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82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9/04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9/04/2021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468848" y="6383191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66021" y="581713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Gastaldelli et al (2021) Diabetologia DOI 10.1007/s00125-021-05442-2</a:t>
            </a:r>
          </a:p>
          <a:p>
            <a:r>
              <a:rPr lang="en-GB" sz="1200" dirty="0"/>
              <a:t>©The Authors 2021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188640"/>
            <a:ext cx="85879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Hepatic effects of treatment either for diabetes or for NAFLD and NASH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8622202-14BA-443C-A69F-AF89D7153F0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95636" y="692696"/>
            <a:ext cx="6552728" cy="5244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3</TotalTime>
  <Words>53</Words>
  <Application>Microsoft Office PowerPoint</Application>
  <PresentationFormat>On-screen Show (4:3)</PresentationFormat>
  <Paragraphs>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39</cp:revision>
  <dcterms:created xsi:type="dcterms:W3CDTF">2016-06-15T12:53:43Z</dcterms:created>
  <dcterms:modified xsi:type="dcterms:W3CDTF">2021-04-09T08:55:24Z</dcterms:modified>
</cp:coreProperties>
</file>